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144000" type="screen4x3"/>
  <p:notesSz cx="6858000" cy="9144000"/>
  <p:defaultTextStyle>
    <a:defPPr>
      <a:defRPr lang="ru-R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3D4BF"/>
    <a:srgbClr val="BFBFFF"/>
    <a:srgbClr val="BFFFB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63" autoAdjust="0"/>
    <p:restoredTop sz="94660"/>
  </p:normalViewPr>
  <p:slideViewPr>
    <p:cSldViewPr snapToGrid="0">
      <p:cViewPr varScale="1">
        <p:scale>
          <a:sx n="88" d="100"/>
          <a:sy n="88" d="100"/>
        </p:scale>
        <p:origin x="1788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Титульны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ru-RU" smtClean="0"/>
              <a:t>Образец заголовка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ru-RU" smtClean="0"/>
              <a:t>Образец подзаголовка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73CF98-32C5-4AA2-94AD-0ECB3EAAD6FC}" type="datetimeFigureOut">
              <a:rPr lang="ru-RU" smtClean="0"/>
              <a:t>13.07.2018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2FC99C-D6AB-4ED7-8224-736BC312ADFD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7539178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Заголовок и вертикальный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73CF98-32C5-4AA2-94AD-0ECB3EAAD6FC}" type="datetimeFigureOut">
              <a:rPr lang="ru-RU" smtClean="0"/>
              <a:t>13.07.2018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2FC99C-D6AB-4ED7-8224-736BC312ADFD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5930717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Вертикальный заголовок и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ru-RU" smtClean="0"/>
              <a:t>Образец заголовка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73CF98-32C5-4AA2-94AD-0ECB3EAAD6FC}" type="datetimeFigureOut">
              <a:rPr lang="ru-RU" smtClean="0"/>
              <a:t>13.07.2018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2FC99C-D6AB-4ED7-8224-736BC312ADFD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6400278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Заголовок и объек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73CF98-32C5-4AA2-94AD-0ECB3EAAD6FC}" type="datetimeFigureOut">
              <a:rPr lang="ru-RU" smtClean="0"/>
              <a:t>13.07.2018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2FC99C-D6AB-4ED7-8224-736BC312ADFD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41794215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Заголовок раздел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ru-RU" smtClean="0"/>
              <a:t>Образец заголовка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73CF98-32C5-4AA2-94AD-0ECB3EAAD6FC}" type="datetimeFigureOut">
              <a:rPr lang="ru-RU" smtClean="0"/>
              <a:t>13.07.2018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2FC99C-D6AB-4ED7-8224-736BC312ADFD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42034084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Два объект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73CF98-32C5-4AA2-94AD-0ECB3EAAD6FC}" type="datetimeFigureOut">
              <a:rPr lang="ru-RU" smtClean="0"/>
              <a:t>13.07.2018</a:t>
            </a:fld>
            <a:endParaRPr lang="ru-R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2FC99C-D6AB-4ED7-8224-736BC312ADFD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5970394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Сравнение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ru-RU" smtClean="0"/>
              <a:t>Образец заголовка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73CF98-32C5-4AA2-94AD-0ECB3EAAD6FC}" type="datetimeFigureOut">
              <a:rPr lang="ru-RU" smtClean="0"/>
              <a:t>13.07.2018</a:t>
            </a:fld>
            <a:endParaRPr lang="ru-R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2FC99C-D6AB-4ED7-8224-736BC312ADFD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4940223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Только заголово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73CF98-32C5-4AA2-94AD-0ECB3EAAD6FC}" type="datetimeFigureOut">
              <a:rPr lang="ru-RU" smtClean="0"/>
              <a:t>13.07.2018</a:t>
            </a:fld>
            <a:endParaRPr lang="ru-R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2FC99C-D6AB-4ED7-8224-736BC312ADFD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5642331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Пусто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73CF98-32C5-4AA2-94AD-0ECB3EAAD6FC}" type="datetimeFigureOut">
              <a:rPr lang="ru-RU" smtClean="0"/>
              <a:t>13.07.2018</a:t>
            </a:fld>
            <a:endParaRPr lang="ru-R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2FC99C-D6AB-4ED7-8224-736BC312ADFD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7902523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Объект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ru-RU" smtClean="0"/>
              <a:t>Образец заголовка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73CF98-32C5-4AA2-94AD-0ECB3EAAD6FC}" type="datetimeFigureOut">
              <a:rPr lang="ru-RU" smtClean="0"/>
              <a:t>13.07.2018</a:t>
            </a:fld>
            <a:endParaRPr lang="ru-R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2FC99C-D6AB-4ED7-8224-736BC312ADFD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1162982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Рисунок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ru-RU" smtClean="0"/>
              <a:t>Образец заголовка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ru-RU" smtClean="0"/>
              <a:t>Вставка рисунка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73CF98-32C5-4AA2-94AD-0ECB3EAAD6FC}" type="datetimeFigureOut">
              <a:rPr lang="ru-RU" smtClean="0"/>
              <a:t>13.07.2018</a:t>
            </a:fld>
            <a:endParaRPr lang="ru-R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2FC99C-D6AB-4ED7-8224-736BC312ADFD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2900202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ru-RU" smtClean="0"/>
              <a:t>Образец заголовка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73CF98-32C5-4AA2-94AD-0ECB3EAAD6FC}" type="datetimeFigureOut">
              <a:rPr lang="ru-RU" smtClean="0"/>
              <a:t>13.07.2018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2FC99C-D6AB-4ED7-8224-736BC312ADFD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3628334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Рисунок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21973" y="1397486"/>
            <a:ext cx="3674395" cy="360000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424542" y="5399314"/>
            <a:ext cx="630114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Figure S2</a:t>
            </a:r>
            <a:r>
              <a:rPr lang="en-US" sz="1400" dirty="0"/>
              <a:t>. Venn diagram of clade-unique and clade-shared amino acid substitutions</a:t>
            </a:r>
            <a:r>
              <a:rPr lang="en-US" sz="1400" dirty="0" smtClean="0"/>
              <a:t>.</a:t>
            </a:r>
            <a:endParaRPr lang="ru-RU" sz="1400" dirty="0"/>
          </a:p>
        </p:txBody>
      </p:sp>
      <p:sp>
        <p:nvSpPr>
          <p:cNvPr id="6" name="Прямоугольник 5"/>
          <p:cNvSpPr/>
          <p:nvPr/>
        </p:nvSpPr>
        <p:spPr>
          <a:xfrm>
            <a:off x="2838684" y="1752601"/>
            <a:ext cx="1219200" cy="298972"/>
          </a:xfrm>
          <a:prstGeom prst="rect">
            <a:avLst/>
          </a:prstGeom>
          <a:solidFill>
            <a:srgbClr val="BFFFB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sp>
        <p:nvSpPr>
          <p:cNvPr id="7" name="Прямоугольник 6"/>
          <p:cNvSpPr/>
          <p:nvPr/>
        </p:nvSpPr>
        <p:spPr>
          <a:xfrm rot="2239904">
            <a:off x="1785190" y="3820790"/>
            <a:ext cx="1219200" cy="398687"/>
          </a:xfrm>
          <a:prstGeom prst="rect">
            <a:avLst/>
          </a:prstGeom>
          <a:solidFill>
            <a:srgbClr val="BFBF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sp>
        <p:nvSpPr>
          <p:cNvPr id="8" name="Прямоугольник 7"/>
          <p:cNvSpPr/>
          <p:nvPr/>
        </p:nvSpPr>
        <p:spPr>
          <a:xfrm rot="19107463">
            <a:off x="3929754" y="3668487"/>
            <a:ext cx="1219200" cy="380999"/>
          </a:xfrm>
          <a:prstGeom prst="rect">
            <a:avLst/>
          </a:prstGeom>
          <a:solidFill>
            <a:srgbClr val="F3D4B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sp>
        <p:nvSpPr>
          <p:cNvPr id="9" name="TextBox 8"/>
          <p:cNvSpPr txBox="1"/>
          <p:nvPr/>
        </p:nvSpPr>
        <p:spPr>
          <a:xfrm>
            <a:off x="2928796" y="1448189"/>
            <a:ext cx="96051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 smtClean="0"/>
              <a:t>Clade C</a:t>
            </a:r>
            <a:endParaRPr lang="ru-RU" sz="2000" dirty="0"/>
          </a:p>
        </p:txBody>
      </p:sp>
      <p:sp>
        <p:nvSpPr>
          <p:cNvPr id="10" name="TextBox 9"/>
          <p:cNvSpPr txBox="1"/>
          <p:nvPr/>
        </p:nvSpPr>
        <p:spPr>
          <a:xfrm>
            <a:off x="1604806" y="3425833"/>
            <a:ext cx="96051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 smtClean="0"/>
              <a:t>Clade B</a:t>
            </a:r>
            <a:endParaRPr lang="ru-RU" sz="2000" dirty="0"/>
          </a:p>
        </p:txBody>
      </p:sp>
      <p:sp>
        <p:nvSpPr>
          <p:cNvPr id="11" name="TextBox 10"/>
          <p:cNvSpPr txBox="1"/>
          <p:nvPr/>
        </p:nvSpPr>
        <p:spPr>
          <a:xfrm>
            <a:off x="4334816" y="3432053"/>
            <a:ext cx="97334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 smtClean="0"/>
              <a:t>Clade A</a:t>
            </a:r>
            <a:endParaRPr lang="ru-RU" sz="2000" dirty="0"/>
          </a:p>
        </p:txBody>
      </p:sp>
    </p:spTree>
    <p:extLst>
      <p:ext uri="{BB962C8B-B14F-4D97-AF65-F5344CB8AC3E}">
        <p14:creationId xmlns:p14="http://schemas.microsoft.com/office/powerpoint/2010/main" val="2330728079"/>
      </p:ext>
    </p:extLst>
  </p:cSld>
  <p:clrMapOvr>
    <a:masterClrMapping/>
  </p:clrMapOvr>
</p:sld>
</file>

<file path=ppt/theme/theme1.xml><?xml version="1.0" encoding="utf-8"?>
<a:theme xmlns:a="http://schemas.openxmlformats.org/drawingml/2006/main" name="Тема Office">
  <a:themeElements>
    <a:clrScheme name="Тема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Тема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Тема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</TotalTime>
  <Words>19</Words>
  <Application>Microsoft Office PowerPoint</Application>
  <PresentationFormat>Экран (4:3)</PresentationFormat>
  <Paragraphs>4</Paragraphs>
  <Slides>1</Slides>
  <Notes>0</Notes>
  <HiddenSlides>0</HiddenSlides>
  <MMClips>0</MMClips>
  <ScaleCrop>false</ScaleCrop>
  <HeadingPairs>
    <vt:vector size="6" baseType="variant">
      <vt:variant>
        <vt:lpstr>Использованные шрифты</vt:lpstr>
      </vt:variant>
      <vt:variant>
        <vt:i4>3</vt:i4>
      </vt:variant>
      <vt:variant>
        <vt:lpstr>Тема</vt:lpstr>
      </vt:variant>
      <vt:variant>
        <vt:i4>1</vt:i4>
      </vt:variant>
      <vt:variant>
        <vt:lpstr>Заголовки слайдов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Тема Office</vt:lpstr>
      <vt:lpstr>Презентация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Презентация PowerPoint</dc:title>
  <dc:creator>Igor Mokrousov</dc:creator>
  <cp:lastModifiedBy>Igor Mokrousov</cp:lastModifiedBy>
  <cp:revision>1</cp:revision>
  <dcterms:created xsi:type="dcterms:W3CDTF">2018-07-13T13:47:58Z</dcterms:created>
  <dcterms:modified xsi:type="dcterms:W3CDTF">2018-07-13T13:55:05Z</dcterms:modified>
</cp:coreProperties>
</file>